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564DFE-318B-4F0C-BEDA-5BB8A40F6C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3F28F-391B-4836-A486-69796867D0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AC033-9DEA-4F54-B140-2472BB8CFC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4A4FA1-DF8D-4BD4-BEF6-3A09ACCD210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15FA50-DD76-4305-9B5A-0DE860117C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2E53BB-3922-4A36-90A1-71F4B7A432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99D73E-82FF-4ADE-B4E6-2375322167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AA29B0-262D-442D-AB44-941BF6C6E7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DAA99C-C7C5-416F-A5B9-84E23E5572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2B447-7AF5-4223-8C01-4D6FAF6014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9DC76-696E-4C0C-AD75-A5E45691EC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A55EC-10FC-4EC6-B583-53625988C2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6A4E82-8E83-497F-ABE8-A758C1F0388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81000" y="395280"/>
          <a:ext cx="4464000" cy="4533840"/>
        </p:xfrm>
        <a:graphic>
          <a:graphicData uri="http://schemas.openxmlformats.org/drawingml/2006/table">
            <a:tbl>
              <a:tblPr/>
              <a:tblGrid>
                <a:gridCol w="720720"/>
                <a:gridCol w="2600280"/>
                <a:gridCol w="1143000"/>
              </a:tblGrid>
              <a:tr h="125280">
                <a:tc gridSpan="3"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ble S2. Plasmids used in 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270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lasm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mportant properti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eference or sourc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564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CR cloning vector, Amp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ome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63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85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275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678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64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87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63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85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275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678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64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87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H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63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H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H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85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H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87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GEM-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LAW3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acB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MCS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oriT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(RK2) Cm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r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loxP ori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(ColE1) Amp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Times New Roman"/>
                        </a:rPr>
                        <a:t>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ox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iater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e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64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63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LAW3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3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LAW3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85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LAW3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3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275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LAW3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64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678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LAW3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72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N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87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::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phA-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LAW34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64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MB2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loning vector derived from RSF10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orales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.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f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72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45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a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MMB2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agai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. (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64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M45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ral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45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alF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MMB2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agai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. (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a-ral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45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a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ralF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MMB2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agai 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t al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. (g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H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45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63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MMB2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H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45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MMB2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64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H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45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a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090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MMB2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672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H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45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a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185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MMB2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564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TH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45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ya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</a:t>
                      </a: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pg2874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in MCS of pMMB2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his stud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5280"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CS; multiple cloning sit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3960" rIns="3960" tIns="39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960" marR="39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テキスト ボックス 3"/>
          <p:cNvSpPr/>
          <p:nvPr/>
        </p:nvSpPr>
        <p:spPr>
          <a:xfrm>
            <a:off x="765000" y="4932360"/>
            <a:ext cx="561672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e. Wiater LA, Sadosky AB, Shuman HA (1994) Mutagenesis of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Legionella  pneumophil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using Tn903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dlllacZ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: identification of a growth-phase-regulated pigmentation gene. Mol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Microbiol 11: 641-653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f. Morales VM, Bäckman A, Bagdasarian MA (1991) A series of wide-host-range low-copy-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number vectors that allow direct screening for recombinants. Gene 97: 39-47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. Nagai H, Cambronne ED, Kagan JC, Amor JC, Kahn RA, et al. (2005) A C-terminal translocation 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signal required for Dot/Icm-dependent delivery of the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Legionell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RalF protein to host cells. Proc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Natl Acad Sci U S A 102: 826-831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04T12:57:45Z</dcterms:created>
  <dc:creator> 平田源内</dc:creator>
  <dc:description/>
  <dc:language>en-US</dc:language>
  <cp:lastModifiedBy>MiyakeMasaki</cp:lastModifiedBy>
  <dcterms:modified xsi:type="dcterms:W3CDTF">2010-06-30T05:31:21Z</dcterms:modified>
  <cp:revision>121</cp:revision>
  <dc:subject/>
  <dc:title>スライド 1</dc:title>
</cp:coreProperties>
</file>